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 varScale="1">
        <p:scale>
          <a:sx n="90" d="100"/>
          <a:sy n="90" d="100"/>
        </p:scale>
        <p:origin x="1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9CC193-E7E1-40E2-9580-D25A5478052B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2C281B-420C-4402-BF7B-5914FFCA14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783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Slide Image Placeholder 1">
            <a:extLst>
              <a:ext uri="{FF2B5EF4-FFF2-40B4-BE49-F238E27FC236}">
                <a16:creationId xmlns:a16="http://schemas.microsoft.com/office/drawing/2014/main" id="{3999D785-7B70-4256-AA23-75B00B1D8F86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0723" name="Notes Placeholder 2">
            <a:extLst>
              <a:ext uri="{FF2B5EF4-FFF2-40B4-BE49-F238E27FC236}">
                <a16:creationId xmlns:a16="http://schemas.microsoft.com/office/drawing/2014/main" id="{29A77AC6-F531-4B5A-870C-312633E499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24" name="Slide Number Placeholder 3">
            <a:extLst>
              <a:ext uri="{FF2B5EF4-FFF2-40B4-BE49-F238E27FC236}">
                <a16:creationId xmlns:a16="http://schemas.microsoft.com/office/drawing/2014/main" id="{ED82B173-198C-4FDB-B461-1342D382ED6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7D9501D5-A408-491B-8721-5383D6C6897C}" type="slidenum">
              <a:rPr lang="en-GB" altLang="en-US">
                <a:solidFill>
                  <a:srgbClr val="000000"/>
                </a:solidFill>
              </a:rPr>
              <a:pPr>
                <a:spcBef>
                  <a:spcPct val="0"/>
                </a:spcBef>
              </a:pPr>
              <a:t>1</a:t>
            </a:fld>
            <a:endParaRPr lang="en-GB" alt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798AE-387A-460C-9E5D-702E0F9B21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CBB19D-6699-4B95-BD08-D2D912D68A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5D6D89-FC1B-4C6E-8835-5FDDAF45A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CE575-8FC9-404B-9B23-78ADC72D4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C932A5-52C0-4B51-81C2-623D00825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5997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A0D854-F101-4F4E-93B2-17F19EC9B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746264-90BC-42E2-98C4-12F5ED8B02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7333A-850B-4C1B-B9C6-78C5A04E8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84E66D-C701-4A6F-8E83-A3ECD0C51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C3F1AC-6D65-4603-A1AE-EEB7AA677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02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E5A4C2-97F9-49C1-87F6-6B69CA757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B557DE-9500-4699-9F0D-17ECCCD563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9DDE4-4FA0-4819-858E-DB9052154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649CC1-B754-4B2D-9EE7-DB3AF97D9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DC842-9DEA-48AD-A4BD-623470BA8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380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C2B1C-DE09-4419-8E74-9651DE5F3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DC0111-1A68-4208-AB51-A87E21B80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471242-9BFB-4E85-A54F-C811120B8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846AEB-78B2-44C0-BAE5-F37342ACA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041CDF-6790-4CB8-9296-FE41E3E58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5023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A07BD5-DC31-4580-85D0-3C23D71AF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507CB-7FB5-4AF4-B1F3-C21488BDAA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8597B8-1674-4C7C-B3C0-6ADE388AF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98BBD-9F03-407D-9240-CCA8EAFCD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16320-5FF4-4BCD-A7EF-D75588523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517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8FFBA-8679-4C6E-B9B6-5214963C3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5CBE44-CB70-44B1-9A70-BAD6C3E567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511837-F5FE-4252-BE04-1B864D0AB1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F58E8E-61CE-4C42-907B-80BFBB44E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825D54-061E-47BA-8331-DABAF0CE8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297F9A-76C7-4A53-AFB3-9B9FA8EF7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4685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3172B-F0F8-4942-87A2-B3A27703B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94DB87-FD0C-43C8-97AF-BAA7486EF5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D505B5-44FF-4FBB-B40F-7FA4822B32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F274BC-0191-4412-9236-64AE71A814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A01259-A678-4FCA-B685-F053ACC5C1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0666FE8-DB1B-4112-98A8-3A6EDEB6F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3E51CE-1DAE-45A5-AEA9-7F5A3370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7754A2-42B7-40C1-886B-7CA2AB983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831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94388-EE87-4FE7-A60D-90D9F2558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1747D4-8632-4335-BE4E-A9C31D817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3A11A3-9AE5-4892-A0DC-FC80A7A47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17E91A-45B7-485A-B5DD-E16228D9E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491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483EC4-4C46-46FA-9B3D-D07C6E26A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A6B2EC-C0EB-4DB9-9F23-2427464C7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D21967-46B0-48B7-BC8E-B4182D332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644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B0F7B-3ED4-4BFA-B183-479989970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07176F-C206-40AB-9B13-A60CE641EC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77D15F-551C-409A-AE92-2895693EB1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41947A-2D10-4565-955E-689789328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F51252-FD59-48E9-87DE-1AA098820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593AC1-001E-4A77-85D9-A20E388CB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53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DBB93-1E97-400F-9DA8-82CC1AFC5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B4961A-E2A6-4775-B6DA-A8E73C8C3B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0DFEC5-9061-49BB-BF75-71E4720A04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8DF11C-B42B-49FF-89F1-D969AD739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13C086-997E-42B8-A3A4-BF7B144EE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1730B6-5224-4E2D-AC0D-D2A3923CF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247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D9BC2D-701F-401D-B6C0-676BF4135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5CD15A-E5AD-4C58-B926-E9684B61D5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21A013-975B-4978-92E7-BEACDCD27E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6EA0D-2022-42C2-9031-FDF18530794E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5A63D-673B-454C-9A77-8C741D2C54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D94ACE-CE08-4D37-BD38-968760563B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AB743-1F14-4AD4-805D-0DF3D0736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7371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B3D8451-DDBF-4D44-9410-29B447212453}"/>
              </a:ext>
            </a:extLst>
          </p:cNvPr>
          <p:cNvSpPr/>
          <p:nvPr/>
        </p:nvSpPr>
        <p:spPr>
          <a:xfrm>
            <a:off x="214312" y="216997"/>
            <a:ext cx="11763375" cy="653573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9698" name="Rectangle 2">
            <a:extLst>
              <a:ext uri="{FF2B5EF4-FFF2-40B4-BE49-F238E27FC236}">
                <a16:creationId xmlns:a16="http://schemas.microsoft.com/office/drawing/2014/main" id="{4381D283-E40D-46EB-9B07-D6E69244C452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3658776" y="92502"/>
            <a:ext cx="8229600" cy="1143000"/>
          </a:xfrm>
        </p:spPr>
        <p:txBody>
          <a:bodyPr>
            <a:normAutofit/>
          </a:bodyPr>
          <a:lstStyle/>
          <a:p>
            <a:r>
              <a:rPr lang="en-GB" altLang="en-US" sz="36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omplement System</a:t>
            </a:r>
          </a:p>
        </p:txBody>
      </p:sp>
      <p:sp>
        <p:nvSpPr>
          <p:cNvPr id="2052" name="Text Box 8">
            <a:extLst>
              <a:ext uri="{FF2B5EF4-FFF2-40B4-BE49-F238E27FC236}">
                <a16:creationId xmlns:a16="http://schemas.microsoft.com/office/drawing/2014/main" id="{73988E42-1018-42DB-92A2-B6C8A0D9EB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9318" y="1133108"/>
            <a:ext cx="2739917" cy="461665"/>
          </a:xfrm>
          <a:prstGeom prst="rect">
            <a:avLst/>
          </a:prstGeom>
          <a:noFill/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400" i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ctivation Pathway</a:t>
            </a:r>
          </a:p>
        </p:txBody>
      </p:sp>
      <p:sp>
        <p:nvSpPr>
          <p:cNvPr id="2053" name="Text Box 10">
            <a:extLst>
              <a:ext uri="{FF2B5EF4-FFF2-40B4-BE49-F238E27FC236}">
                <a16:creationId xmlns:a16="http://schemas.microsoft.com/office/drawing/2014/main" id="{871ADA47-EC48-40FB-88B2-DB15D27F09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8967" y="4156076"/>
            <a:ext cx="1731308" cy="830997"/>
          </a:xfrm>
          <a:prstGeom prst="rect">
            <a:avLst/>
          </a:prstGeom>
          <a:noFill/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4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lternative </a:t>
            </a:r>
          </a:p>
          <a:p>
            <a:pPr eaLnBrk="1" hangingPunct="1">
              <a:defRPr/>
            </a:pPr>
            <a:r>
              <a:rPr lang="en-GB" sz="24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hway</a:t>
            </a:r>
          </a:p>
        </p:txBody>
      </p:sp>
      <p:sp>
        <p:nvSpPr>
          <p:cNvPr id="2054" name="Rectangle 11">
            <a:extLst>
              <a:ext uri="{FF2B5EF4-FFF2-40B4-BE49-F238E27FC236}">
                <a16:creationId xmlns:a16="http://schemas.microsoft.com/office/drawing/2014/main" id="{AD3DB98E-D8E5-4902-A62A-50A6505DB3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6986" y="3036888"/>
            <a:ext cx="2173288" cy="708025"/>
          </a:xfrm>
          <a:prstGeom prst="rect">
            <a:avLst/>
          </a:prstGeom>
          <a:noFill/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annose-binding</a:t>
            </a:r>
          </a:p>
          <a:p>
            <a:pPr eaLnBrk="1" hangingPunct="1">
              <a:defRPr/>
            </a:pPr>
            <a:r>
              <a:rPr lang="en-GB" sz="2000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lectin</a:t>
            </a:r>
            <a:r>
              <a:rPr lang="en-GB" sz="2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pathway</a:t>
            </a:r>
          </a:p>
        </p:txBody>
      </p:sp>
      <p:sp>
        <p:nvSpPr>
          <p:cNvPr id="2055" name="Text Box 15">
            <a:extLst>
              <a:ext uri="{FF2B5EF4-FFF2-40B4-BE49-F238E27FC236}">
                <a16:creationId xmlns:a16="http://schemas.microsoft.com/office/drawing/2014/main" id="{E9924F5F-53F7-46EC-A427-19F1AE1C10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2400" y="3141663"/>
            <a:ext cx="615950" cy="519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</a:t>
            </a:r>
          </a:p>
        </p:txBody>
      </p:sp>
      <p:sp>
        <p:nvSpPr>
          <p:cNvPr id="2056" name="Line 16">
            <a:extLst>
              <a:ext uri="{FF2B5EF4-FFF2-40B4-BE49-F238E27FC236}">
                <a16:creationId xmlns:a16="http://schemas.microsoft.com/office/drawing/2014/main" id="{2E837824-9525-4E11-AE21-3D83CC23B055}"/>
              </a:ext>
            </a:extLst>
          </p:cNvPr>
          <p:cNvSpPr>
            <a:spLocks noChangeShapeType="1"/>
          </p:cNvSpPr>
          <p:nvPr/>
        </p:nvSpPr>
        <p:spPr bwMode="auto">
          <a:xfrm>
            <a:off x="5880100" y="3357563"/>
            <a:ext cx="431800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2057" name="Text Box 17">
            <a:extLst>
              <a:ext uri="{FF2B5EF4-FFF2-40B4-BE49-F238E27FC236}">
                <a16:creationId xmlns:a16="http://schemas.microsoft.com/office/drawing/2014/main" id="{DBA381AD-E4DF-4875-A376-57D2D8AB41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1901" y="3203575"/>
            <a:ext cx="57740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b</a:t>
            </a:r>
          </a:p>
        </p:txBody>
      </p:sp>
      <p:grpSp>
        <p:nvGrpSpPr>
          <p:cNvPr id="29705" name="Group 26">
            <a:extLst>
              <a:ext uri="{FF2B5EF4-FFF2-40B4-BE49-F238E27FC236}">
                <a16:creationId xmlns:a16="http://schemas.microsoft.com/office/drawing/2014/main" id="{6CAED7A7-C631-4724-8468-F64F2162E1C1}"/>
              </a:ext>
            </a:extLst>
          </p:cNvPr>
          <p:cNvGrpSpPr>
            <a:grpSpLocks/>
          </p:cNvGrpSpPr>
          <p:nvPr/>
        </p:nvGrpSpPr>
        <p:grpSpPr bwMode="auto">
          <a:xfrm>
            <a:off x="2842245" y="2476501"/>
            <a:ext cx="2390155" cy="544512"/>
            <a:chOff x="792" y="1106"/>
            <a:chExt cx="1497" cy="1195"/>
          </a:xfrm>
        </p:grpSpPr>
        <p:sp>
          <p:nvSpPr>
            <p:cNvPr id="2113" name="Freeform 12">
              <a:extLst>
                <a:ext uri="{FF2B5EF4-FFF2-40B4-BE49-F238E27FC236}">
                  <a16:creationId xmlns:a16="http://schemas.microsoft.com/office/drawing/2014/main" id="{62E90ABD-6AB7-4022-B2EF-E76A27A487A6}"/>
                </a:ext>
              </a:extLst>
            </p:cNvPr>
            <p:cNvSpPr>
              <a:spLocks/>
            </p:cNvSpPr>
            <p:nvPr/>
          </p:nvSpPr>
          <p:spPr bwMode="auto">
            <a:xfrm>
              <a:off x="792" y="1106"/>
              <a:ext cx="1497" cy="1195"/>
            </a:xfrm>
            <a:custGeom>
              <a:avLst/>
              <a:gdLst>
                <a:gd name="T0" fmla="*/ 0 w 1497"/>
                <a:gd name="T1" fmla="*/ 0 h 1195"/>
                <a:gd name="T2" fmla="*/ 318 w 1497"/>
                <a:gd name="T3" fmla="*/ 816 h 1195"/>
                <a:gd name="T4" fmla="*/ 1316 w 1497"/>
                <a:gd name="T5" fmla="*/ 1134 h 1195"/>
                <a:gd name="T6" fmla="*/ 1407 w 1497"/>
                <a:gd name="T7" fmla="*/ 1179 h 119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497"/>
                <a:gd name="T13" fmla="*/ 0 h 1195"/>
                <a:gd name="T14" fmla="*/ 1497 w 1497"/>
                <a:gd name="T15" fmla="*/ 1195 h 119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497" h="1195">
                  <a:moveTo>
                    <a:pt x="0" y="0"/>
                  </a:moveTo>
                  <a:cubicBezTo>
                    <a:pt x="49" y="313"/>
                    <a:pt x="99" y="627"/>
                    <a:pt x="318" y="816"/>
                  </a:cubicBezTo>
                  <a:cubicBezTo>
                    <a:pt x="537" y="1005"/>
                    <a:pt x="1135" y="1073"/>
                    <a:pt x="1316" y="1134"/>
                  </a:cubicBezTo>
                  <a:cubicBezTo>
                    <a:pt x="1497" y="1195"/>
                    <a:pt x="1400" y="1172"/>
                    <a:pt x="1407" y="1179"/>
                  </a:cubicBezTo>
                </a:path>
              </a:pathLst>
            </a:cu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US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2114" name="Line 18">
              <a:extLst>
                <a:ext uri="{FF2B5EF4-FFF2-40B4-BE49-F238E27FC236}">
                  <a16:creationId xmlns:a16="http://schemas.microsoft.com/office/drawing/2014/main" id="{4293D4AC-2081-4B11-87FC-9DFDD54211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2" y="2253"/>
              <a:ext cx="91" cy="4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sp>
        <p:nvSpPr>
          <p:cNvPr id="2059" name="Line 22">
            <a:extLst>
              <a:ext uri="{FF2B5EF4-FFF2-40B4-BE49-F238E27FC236}">
                <a16:creationId xmlns:a16="http://schemas.microsoft.com/office/drawing/2014/main" id="{C566E18D-8BF3-4942-B47A-E09403F9A427}"/>
              </a:ext>
            </a:extLst>
          </p:cNvPr>
          <p:cNvSpPr>
            <a:spLocks noChangeShapeType="1"/>
          </p:cNvSpPr>
          <p:nvPr/>
        </p:nvSpPr>
        <p:spPr bwMode="auto">
          <a:xfrm>
            <a:off x="4008439" y="3429000"/>
            <a:ext cx="1150937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2060" name="Line 23">
            <a:extLst>
              <a:ext uri="{FF2B5EF4-FFF2-40B4-BE49-F238E27FC236}">
                <a16:creationId xmlns:a16="http://schemas.microsoft.com/office/drawing/2014/main" id="{75CAC20D-C2E2-4CD9-994B-050987A7D3DF}"/>
              </a:ext>
            </a:extLst>
          </p:cNvPr>
          <p:cNvSpPr>
            <a:spLocks noChangeShapeType="1"/>
          </p:cNvSpPr>
          <p:nvPr/>
        </p:nvSpPr>
        <p:spPr bwMode="auto">
          <a:xfrm>
            <a:off x="6888164" y="3370263"/>
            <a:ext cx="287337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grpSp>
        <p:nvGrpSpPr>
          <p:cNvPr id="29708" name="Group 35">
            <a:extLst>
              <a:ext uri="{FF2B5EF4-FFF2-40B4-BE49-F238E27FC236}">
                <a16:creationId xmlns:a16="http://schemas.microsoft.com/office/drawing/2014/main" id="{81BA6462-DF8A-4822-BF3E-E0E990F4E192}"/>
              </a:ext>
            </a:extLst>
          </p:cNvPr>
          <p:cNvGrpSpPr>
            <a:grpSpLocks/>
          </p:cNvGrpSpPr>
          <p:nvPr/>
        </p:nvGrpSpPr>
        <p:grpSpPr bwMode="auto">
          <a:xfrm>
            <a:off x="3000275" y="3716337"/>
            <a:ext cx="2305150" cy="1027111"/>
            <a:chOff x="1338" y="2341"/>
            <a:chExt cx="1044" cy="635"/>
          </a:xfrm>
        </p:grpSpPr>
        <p:sp>
          <p:nvSpPr>
            <p:cNvPr id="2111" name="Line 20">
              <a:extLst>
                <a:ext uri="{FF2B5EF4-FFF2-40B4-BE49-F238E27FC236}">
                  <a16:creationId xmlns:a16="http://schemas.microsoft.com/office/drawing/2014/main" id="{C01D8FED-CB6D-4CE3-974E-9464B95927A2}"/>
                </a:ext>
              </a:extLst>
            </p:cNvPr>
            <p:cNvSpPr>
              <a:spLocks noChangeShapeType="1"/>
            </p:cNvSpPr>
            <p:nvPr/>
          </p:nvSpPr>
          <p:spPr bwMode="auto">
            <a:xfrm rot="10635824" flipH="1">
              <a:off x="2336" y="2341"/>
              <a:ext cx="46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2112" name="Freeform 34">
              <a:extLst>
                <a:ext uri="{FF2B5EF4-FFF2-40B4-BE49-F238E27FC236}">
                  <a16:creationId xmlns:a16="http://schemas.microsoft.com/office/drawing/2014/main" id="{FAE5F3CC-202B-40A0-85E2-490DF88EDD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8" y="2341"/>
              <a:ext cx="1021" cy="635"/>
            </a:xfrm>
            <a:custGeom>
              <a:avLst/>
              <a:gdLst>
                <a:gd name="T0" fmla="*/ 68 w 1021"/>
                <a:gd name="T1" fmla="*/ 635 h 635"/>
                <a:gd name="T2" fmla="*/ 159 w 1021"/>
                <a:gd name="T3" fmla="*/ 318 h 635"/>
                <a:gd name="T4" fmla="*/ 1021 w 1021"/>
                <a:gd name="T5" fmla="*/ 0 h 635"/>
                <a:gd name="T6" fmla="*/ 0 60000 65536"/>
                <a:gd name="T7" fmla="*/ 0 60000 65536"/>
                <a:gd name="T8" fmla="*/ 0 60000 65536"/>
                <a:gd name="T9" fmla="*/ 0 w 1021"/>
                <a:gd name="T10" fmla="*/ 0 h 635"/>
                <a:gd name="T11" fmla="*/ 1021 w 1021"/>
                <a:gd name="T12" fmla="*/ 635 h 63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21" h="635">
                  <a:moveTo>
                    <a:pt x="68" y="635"/>
                  </a:moveTo>
                  <a:cubicBezTo>
                    <a:pt x="34" y="529"/>
                    <a:pt x="0" y="424"/>
                    <a:pt x="159" y="318"/>
                  </a:cubicBezTo>
                  <a:cubicBezTo>
                    <a:pt x="318" y="212"/>
                    <a:pt x="669" y="106"/>
                    <a:pt x="1021" y="0"/>
                  </a:cubicBezTo>
                </a:path>
              </a:pathLst>
            </a:cu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US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grpSp>
        <p:nvGrpSpPr>
          <p:cNvPr id="29710" name="Group 44">
            <a:extLst>
              <a:ext uri="{FF2B5EF4-FFF2-40B4-BE49-F238E27FC236}">
                <a16:creationId xmlns:a16="http://schemas.microsoft.com/office/drawing/2014/main" id="{5B215829-E21F-481E-A886-76A9FCD21E39}"/>
              </a:ext>
            </a:extLst>
          </p:cNvPr>
          <p:cNvGrpSpPr>
            <a:grpSpLocks/>
          </p:cNvGrpSpPr>
          <p:nvPr/>
        </p:nvGrpSpPr>
        <p:grpSpPr bwMode="auto">
          <a:xfrm rot="5400000">
            <a:off x="5124450" y="2528888"/>
            <a:ext cx="863600" cy="215900"/>
            <a:chOff x="839" y="3775"/>
            <a:chExt cx="862" cy="136"/>
          </a:xfrm>
        </p:grpSpPr>
        <p:sp>
          <p:nvSpPr>
            <p:cNvPr id="2107" name="Line 45">
              <a:extLst>
                <a:ext uri="{FF2B5EF4-FFF2-40B4-BE49-F238E27FC236}">
                  <a16:creationId xmlns:a16="http://schemas.microsoft.com/office/drawing/2014/main" id="{ED3683E6-876D-46F2-94E6-F5B0212A12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" y="3838"/>
              <a:ext cx="86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2108" name="Line 46">
              <a:extLst>
                <a:ext uri="{FF2B5EF4-FFF2-40B4-BE49-F238E27FC236}">
                  <a16:creationId xmlns:a16="http://schemas.microsoft.com/office/drawing/2014/main" id="{263A4951-4978-453E-AEDB-853D90CAE7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1" y="3775"/>
              <a:ext cx="0" cy="136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24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sp>
        <p:nvSpPr>
          <p:cNvPr id="2073" name="Text Box 54">
            <a:extLst>
              <a:ext uri="{FF2B5EF4-FFF2-40B4-BE49-F238E27FC236}">
                <a16:creationId xmlns:a16="http://schemas.microsoft.com/office/drawing/2014/main" id="{B54D602D-4BA9-4879-B324-5613E61BD2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4355" y="4730046"/>
            <a:ext cx="4491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</a:t>
            </a:r>
          </a:p>
        </p:txBody>
      </p:sp>
      <p:sp>
        <p:nvSpPr>
          <p:cNvPr id="2074" name="Text Box 55">
            <a:extLst>
              <a:ext uri="{FF2B5EF4-FFF2-40B4-BE49-F238E27FC236}">
                <a16:creationId xmlns:a16="http://schemas.microsoft.com/office/drawing/2014/main" id="{5BDFFD85-1569-41BB-ABE5-722DC7EFF0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5413" y="4221164"/>
            <a:ext cx="141596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actors B, D</a:t>
            </a:r>
          </a:p>
        </p:txBody>
      </p:sp>
      <p:sp>
        <p:nvSpPr>
          <p:cNvPr id="2075" name="Text Box 56">
            <a:extLst>
              <a:ext uri="{FF2B5EF4-FFF2-40B4-BE49-F238E27FC236}">
                <a16:creationId xmlns:a16="http://schemas.microsoft.com/office/drawing/2014/main" id="{7B58A8E8-3367-4A78-85C5-AFE085CB8C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3113" y="3860800"/>
            <a:ext cx="11601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roperdin</a:t>
            </a:r>
          </a:p>
        </p:txBody>
      </p:sp>
      <p:sp>
        <p:nvSpPr>
          <p:cNvPr id="2076" name="Text Box 57">
            <a:extLst>
              <a:ext uri="{FF2B5EF4-FFF2-40B4-BE49-F238E27FC236}">
                <a16:creationId xmlns:a16="http://schemas.microsoft.com/office/drawing/2014/main" id="{FA56564C-FCF0-457B-9B21-48102FF24E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1425" y="1773239"/>
            <a:ext cx="1189038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actor H</a:t>
            </a:r>
          </a:p>
        </p:txBody>
      </p:sp>
      <p:sp>
        <p:nvSpPr>
          <p:cNvPr id="2078" name="Line 76">
            <a:extLst>
              <a:ext uri="{FF2B5EF4-FFF2-40B4-BE49-F238E27FC236}">
                <a16:creationId xmlns:a16="http://schemas.microsoft.com/office/drawing/2014/main" id="{3C16D9F3-2147-44AD-AD18-3F70E65FC7D4}"/>
              </a:ext>
            </a:extLst>
          </p:cNvPr>
          <p:cNvSpPr>
            <a:spLocks noChangeShapeType="1"/>
          </p:cNvSpPr>
          <p:nvPr/>
        </p:nvSpPr>
        <p:spPr bwMode="auto">
          <a:xfrm>
            <a:off x="5951538" y="3716338"/>
            <a:ext cx="576262" cy="596900"/>
          </a:xfrm>
          <a:prstGeom prst="line">
            <a:avLst/>
          </a:prstGeom>
          <a:noFill/>
          <a:ln w="38100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2080" name="Text Box 78">
            <a:extLst>
              <a:ext uri="{FF2B5EF4-FFF2-40B4-BE49-F238E27FC236}">
                <a16:creationId xmlns:a16="http://schemas.microsoft.com/office/drawing/2014/main" id="{A375798A-7BBF-4EBB-93F9-AF153D9427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83338" y="4292600"/>
            <a:ext cx="584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a</a:t>
            </a:r>
          </a:p>
        </p:txBody>
      </p:sp>
      <p:sp>
        <p:nvSpPr>
          <p:cNvPr id="29727" name="TextBox 66">
            <a:extLst>
              <a:ext uri="{FF2B5EF4-FFF2-40B4-BE49-F238E27FC236}">
                <a16:creationId xmlns:a16="http://schemas.microsoft.com/office/drawing/2014/main" id="{ACFE6C06-6470-495E-80BE-3062E0256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8526" y="3068638"/>
            <a:ext cx="1120775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erminal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hway</a:t>
            </a:r>
          </a:p>
        </p:txBody>
      </p:sp>
      <p:sp>
        <p:nvSpPr>
          <p:cNvPr id="68" name="Line 76">
            <a:extLst>
              <a:ext uri="{FF2B5EF4-FFF2-40B4-BE49-F238E27FC236}">
                <a16:creationId xmlns:a16="http://schemas.microsoft.com/office/drawing/2014/main" id="{0C38FBF8-10EA-4532-BECB-20A5F3511179}"/>
              </a:ext>
            </a:extLst>
          </p:cNvPr>
          <p:cNvSpPr>
            <a:spLocks noChangeShapeType="1"/>
          </p:cNvSpPr>
          <p:nvPr/>
        </p:nvSpPr>
        <p:spPr bwMode="auto">
          <a:xfrm>
            <a:off x="6743701" y="4652963"/>
            <a:ext cx="792163" cy="812800"/>
          </a:xfrm>
          <a:prstGeom prst="line">
            <a:avLst/>
          </a:prstGeom>
          <a:noFill/>
          <a:ln w="38100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70" name="Text Box 78">
            <a:extLst>
              <a:ext uri="{FF2B5EF4-FFF2-40B4-BE49-F238E27FC236}">
                <a16:creationId xmlns:a16="http://schemas.microsoft.com/office/drawing/2014/main" id="{69A0234B-C1DC-4A6F-9D20-51C676A07F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32625" y="5589588"/>
            <a:ext cx="14482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a(</a:t>
            </a:r>
            <a:r>
              <a:rPr lang="en-GB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esArg</a:t>
            </a:r>
            <a:r>
              <a:rPr lang="en-GB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)</a:t>
            </a:r>
          </a:p>
        </p:txBody>
      </p:sp>
      <p:sp>
        <p:nvSpPr>
          <p:cNvPr id="29731" name="Arc 82">
            <a:extLst>
              <a:ext uri="{FF2B5EF4-FFF2-40B4-BE49-F238E27FC236}">
                <a16:creationId xmlns:a16="http://schemas.microsoft.com/office/drawing/2014/main" id="{9DC10A4C-D4FB-4C32-BDF4-B6BEB3CC31D6}"/>
              </a:ext>
            </a:extLst>
          </p:cNvPr>
          <p:cNvSpPr>
            <a:spLocks/>
          </p:cNvSpPr>
          <p:nvPr/>
        </p:nvSpPr>
        <p:spPr bwMode="auto">
          <a:xfrm rot="15903566">
            <a:off x="5731669" y="2653507"/>
            <a:ext cx="852488" cy="987425"/>
          </a:xfrm>
          <a:custGeom>
            <a:avLst/>
            <a:gdLst>
              <a:gd name="T0" fmla="*/ 426245 w 851764"/>
              <a:gd name="T1" fmla="*/ 0 h 986523"/>
              <a:gd name="T2" fmla="*/ 426244 w 851764"/>
              <a:gd name="T3" fmla="*/ 493713 h 986523"/>
              <a:gd name="T4" fmla="*/ 310369 w 851764"/>
              <a:gd name="T5" fmla="*/ 968831 h 986523"/>
              <a:gd name="T6" fmla="*/ 11796480 60000 65536"/>
              <a:gd name="T7" fmla="*/ 11796480 60000 65536"/>
              <a:gd name="T8" fmla="*/ 11796480 60000 65536"/>
              <a:gd name="T9" fmla="*/ 310105 w 851764"/>
              <a:gd name="T10" fmla="*/ 0 h 986523"/>
              <a:gd name="T11" fmla="*/ 851764 w 851764"/>
              <a:gd name="T12" fmla="*/ 986523 h 98652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851764" h="986523" stroke="0">
                <a:moveTo>
                  <a:pt x="425883" y="0"/>
                </a:moveTo>
                <a:lnTo>
                  <a:pt x="425882" y="-1"/>
                </a:lnTo>
                <a:cubicBezTo>
                  <a:pt x="661090" y="0"/>
                  <a:pt x="851764" y="220841"/>
                  <a:pt x="851764" y="493262"/>
                </a:cubicBezTo>
                <a:cubicBezTo>
                  <a:pt x="851764" y="765683"/>
                  <a:pt x="661090" y="986524"/>
                  <a:pt x="425882" y="986524"/>
                </a:cubicBezTo>
                <a:cubicBezTo>
                  <a:pt x="386735" y="986523"/>
                  <a:pt x="347776" y="980272"/>
                  <a:pt x="310104" y="967946"/>
                </a:cubicBezTo>
                <a:lnTo>
                  <a:pt x="425882" y="493262"/>
                </a:lnTo>
                <a:lnTo>
                  <a:pt x="425883" y="0"/>
                </a:lnTo>
                <a:close/>
              </a:path>
              <a:path w="851764" h="986523" fill="none">
                <a:moveTo>
                  <a:pt x="425883" y="0"/>
                </a:moveTo>
                <a:lnTo>
                  <a:pt x="425882" y="-1"/>
                </a:lnTo>
                <a:cubicBezTo>
                  <a:pt x="661090" y="0"/>
                  <a:pt x="851764" y="220841"/>
                  <a:pt x="851764" y="493262"/>
                </a:cubicBezTo>
                <a:cubicBezTo>
                  <a:pt x="851764" y="765683"/>
                  <a:pt x="661090" y="986524"/>
                  <a:pt x="425882" y="986524"/>
                </a:cubicBezTo>
                <a:cubicBezTo>
                  <a:pt x="386735" y="986523"/>
                  <a:pt x="347776" y="980272"/>
                  <a:pt x="310104" y="967946"/>
                </a:cubicBezTo>
              </a:path>
            </a:pathLst>
          </a:custGeom>
          <a:noFill/>
          <a:ln w="25400" cap="flat" cmpd="sng" algn="ctr">
            <a:solidFill>
              <a:schemeClr val="bg1"/>
            </a:solidFill>
            <a:prstDash val="solid"/>
            <a:round/>
            <a:headEnd/>
            <a:tailEnd/>
          </a:ln>
          <a:effectLst>
            <a:outerShdw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/>
          <a:lstStyle/>
          <a:p>
            <a:endParaRPr lang="en-GB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29732" name="TextBox 83">
            <a:extLst>
              <a:ext uri="{FF2B5EF4-FFF2-40B4-BE49-F238E27FC236}">
                <a16:creationId xmlns:a16="http://schemas.microsoft.com/office/drawing/2014/main" id="{526A5164-25C0-4A02-9333-FD745AFCEE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5639" y="2205038"/>
            <a:ext cx="2447925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mplification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Loop</a:t>
            </a:r>
          </a:p>
        </p:txBody>
      </p:sp>
      <p:sp>
        <p:nvSpPr>
          <p:cNvPr id="58" name="Text Box 8">
            <a:extLst>
              <a:ext uri="{FF2B5EF4-FFF2-40B4-BE49-F238E27FC236}">
                <a16:creationId xmlns:a16="http://schemas.microsoft.com/office/drawing/2014/main" id="{617049E9-B0D0-4BF4-992F-F99FE4DB95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8526" y="1080740"/>
            <a:ext cx="2571666" cy="461665"/>
          </a:xfrm>
          <a:prstGeom prst="rect">
            <a:avLst/>
          </a:prstGeom>
          <a:noFill/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400" i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erminal Pathway</a:t>
            </a:r>
          </a:p>
        </p:txBody>
      </p:sp>
      <p:sp>
        <p:nvSpPr>
          <p:cNvPr id="59" name="Text Box 8">
            <a:extLst>
              <a:ext uri="{FF2B5EF4-FFF2-40B4-BE49-F238E27FC236}">
                <a16:creationId xmlns:a16="http://schemas.microsoft.com/office/drawing/2014/main" id="{2D1AE0DF-8301-46D7-A07D-E48EB92DD2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7379" y="1986995"/>
            <a:ext cx="1418978" cy="830997"/>
          </a:xfrm>
          <a:prstGeom prst="rect">
            <a:avLst/>
          </a:prstGeom>
          <a:noFill/>
          <a:ln w="9525">
            <a:solidFill>
              <a:srgbClr val="0070C0"/>
            </a:solidFill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24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lassical </a:t>
            </a:r>
          </a:p>
          <a:p>
            <a:pPr eaLnBrk="1" hangingPunct="1">
              <a:defRPr/>
            </a:pPr>
            <a:r>
              <a:rPr lang="en-GB" sz="24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hway</a:t>
            </a:r>
          </a:p>
        </p:txBody>
      </p:sp>
      <p:sp>
        <p:nvSpPr>
          <p:cNvPr id="63" name="Line 23">
            <a:extLst>
              <a:ext uri="{FF2B5EF4-FFF2-40B4-BE49-F238E27FC236}">
                <a16:creationId xmlns:a16="http://schemas.microsoft.com/office/drawing/2014/main" id="{5AB1160E-C111-46C5-BF02-208463EC4504}"/>
              </a:ext>
            </a:extLst>
          </p:cNvPr>
          <p:cNvSpPr>
            <a:spLocks noChangeShapeType="1"/>
          </p:cNvSpPr>
          <p:nvPr/>
        </p:nvSpPr>
        <p:spPr bwMode="auto">
          <a:xfrm>
            <a:off x="8304576" y="3417888"/>
            <a:ext cx="287337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24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64" name="TextBox 66">
            <a:extLst>
              <a:ext uri="{FF2B5EF4-FFF2-40B4-BE49-F238E27FC236}">
                <a16:creationId xmlns:a16="http://schemas.microsoft.com/office/drawing/2014/main" id="{27B7CAC9-C8C4-4119-9FD7-7B406D79AD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91913" y="3047207"/>
            <a:ext cx="1465466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erminal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omplement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omplex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GB" altLang="en-US" sz="18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6244867-DF9A-4B7E-B787-7CAA4658F52B}"/>
              </a:ext>
            </a:extLst>
          </p:cNvPr>
          <p:cNvSpPr txBox="1"/>
          <p:nvPr/>
        </p:nvSpPr>
        <p:spPr>
          <a:xfrm>
            <a:off x="3446218" y="2527831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4</a:t>
            </a:r>
            <a:endParaRPr lang="en-GB" dirty="0"/>
          </a:p>
        </p:txBody>
      </p:sp>
    </p:spTree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Office PowerPoint</Application>
  <PresentationFormat>Widescreen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Complement System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lement System</dc:title>
  <dc:creator>Aled Rees</dc:creator>
  <cp:lastModifiedBy>Aled Rees</cp:lastModifiedBy>
  <cp:revision>2</cp:revision>
  <dcterms:created xsi:type="dcterms:W3CDTF">2020-07-31T11:46:00Z</dcterms:created>
  <dcterms:modified xsi:type="dcterms:W3CDTF">2020-07-31T12:02:21Z</dcterms:modified>
</cp:coreProperties>
</file>